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2192000" cy="16256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1378" y="62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903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1304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6425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5110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3381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5383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3994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1929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7900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2600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2542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D6021-7CEE-4FEE-A8B1-AC1B82C2EE11}" type="datetimeFigureOut">
              <a:rPr lang="fr-FR" smtClean="0"/>
              <a:t>30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0825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/>
          <p:cNvGrpSpPr/>
          <p:nvPr/>
        </p:nvGrpSpPr>
        <p:grpSpPr>
          <a:xfrm>
            <a:off x="1009001" y="6379328"/>
            <a:ext cx="4559391" cy="3710786"/>
            <a:chOff x="2590103" y="1478943"/>
            <a:chExt cx="4939341" cy="4020020"/>
          </a:xfrm>
        </p:grpSpPr>
        <p:sp>
          <p:nvSpPr>
            <p:cNvPr id="4" name="Ellipse 3"/>
            <p:cNvSpPr/>
            <p:nvPr/>
          </p:nvSpPr>
          <p:spPr>
            <a:xfrm>
              <a:off x="3260035" y="1478943"/>
              <a:ext cx="2345635" cy="2274073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4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Ellipse 4"/>
            <p:cNvSpPr/>
            <p:nvPr/>
          </p:nvSpPr>
          <p:spPr>
            <a:xfrm>
              <a:off x="3790122" y="2378766"/>
              <a:ext cx="2345635" cy="2274073"/>
            </a:xfrm>
            <a:prstGeom prst="ellips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4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Ellipse 5"/>
            <p:cNvSpPr/>
            <p:nvPr/>
          </p:nvSpPr>
          <p:spPr>
            <a:xfrm>
              <a:off x="4320209" y="1478943"/>
              <a:ext cx="2345635" cy="2274073"/>
            </a:xfrm>
            <a:prstGeom prst="ellipse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4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6675321" y="1637046"/>
              <a:ext cx="854123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  <a:r>
                <a:rPr lang="fr-FR" sz="1641" dirty="0" err="1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fr-FR" sz="164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4761602" y="4832147"/>
              <a:ext cx="477908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F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626581" y="1637046"/>
              <a:ext cx="566475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4745570" y="2767054"/>
              <a:ext cx="453596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6734932" y="2084566"/>
              <a:ext cx="580368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590103" y="2084566"/>
              <a:ext cx="580368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2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687061" y="5125388"/>
              <a:ext cx="580368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7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5512895" y="3102334"/>
              <a:ext cx="453596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3968431" y="3102334"/>
              <a:ext cx="453596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753587" y="1830125"/>
              <a:ext cx="453596" cy="373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6832839" y="6379326"/>
            <a:ext cx="4525719" cy="3698192"/>
            <a:chOff x="2626581" y="1478943"/>
            <a:chExt cx="4902862" cy="4006373"/>
          </a:xfrm>
        </p:grpSpPr>
        <p:sp>
          <p:nvSpPr>
            <p:cNvPr id="20" name="Ellipse 19"/>
            <p:cNvSpPr/>
            <p:nvPr/>
          </p:nvSpPr>
          <p:spPr>
            <a:xfrm>
              <a:off x="3260035" y="1478943"/>
              <a:ext cx="2345635" cy="2274073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4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Ellipse 20"/>
            <p:cNvSpPr/>
            <p:nvPr/>
          </p:nvSpPr>
          <p:spPr>
            <a:xfrm>
              <a:off x="3790122" y="2378766"/>
              <a:ext cx="2345635" cy="2274073"/>
            </a:xfrm>
            <a:prstGeom prst="ellips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4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Ellipse 21"/>
            <p:cNvSpPr/>
            <p:nvPr/>
          </p:nvSpPr>
          <p:spPr>
            <a:xfrm>
              <a:off x="4320209" y="1478943"/>
              <a:ext cx="2345635" cy="2274073"/>
            </a:xfrm>
            <a:prstGeom prst="ellipse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4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675320" y="1637048"/>
              <a:ext cx="854123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  <a:r>
                <a:rPr lang="fr-FR" sz="1641" dirty="0" err="1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fr-FR" sz="164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761603" y="4832147"/>
              <a:ext cx="477908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F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2626581" y="1637048"/>
              <a:ext cx="566475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4745573" y="2767055"/>
              <a:ext cx="45359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6803167" y="2084568"/>
              <a:ext cx="45359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3</a:t>
              </a: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2644689" y="2084568"/>
              <a:ext cx="45359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4741654" y="5111742"/>
              <a:ext cx="45359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5605670" y="3109238"/>
              <a:ext cx="32682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3968431" y="3102334"/>
              <a:ext cx="32682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4810739" y="1830127"/>
              <a:ext cx="326826" cy="3735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4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</p:grpSp>
      <p:sp>
        <p:nvSpPr>
          <p:cNvPr id="34" name="ZoneTexte 33"/>
          <p:cNvSpPr txBox="1"/>
          <p:nvPr/>
        </p:nvSpPr>
        <p:spPr>
          <a:xfrm>
            <a:off x="1748212" y="10139683"/>
            <a:ext cx="3021981" cy="5973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75133" indent="-375133" algn="ctr">
              <a:buAutoNum type="arabicPlain" startAt="227"/>
            </a:pPr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exon </a:t>
            </a:r>
            <a:r>
              <a:rPr lang="fr-FR" sz="1641" dirty="0" err="1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endParaRPr lang="fr-FR" sz="164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641" dirty="0" err="1">
                <a:latin typeface="Arial" panose="020B0604020202020204" pitchFamily="34" charset="0"/>
                <a:cs typeface="Arial" panose="020B0604020202020204" pitchFamily="34" charset="0"/>
              </a:rPr>
              <a:t>including</a:t>
            </a:r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 US RNA and 2LTR) 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7577176" y="10139683"/>
            <a:ext cx="2964273" cy="5973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68 </a:t>
            </a:r>
            <a:r>
              <a:rPr lang="fr-FR" sz="164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forms</a:t>
            </a:r>
            <a:r>
              <a:rPr lang="fr-FR" sz="1641" dirty="0" smtClean="0">
                <a:latin typeface="Arial" panose="020B0604020202020204" pitchFamily="34" charset="0"/>
                <a:cs typeface="Arial" panose="020B0604020202020204" pitchFamily="34" charset="0"/>
              </a:rPr>
              <a:t> ≥5 </a:t>
            </a:r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copies</a:t>
            </a:r>
          </a:p>
          <a:p>
            <a:pPr algn="ctr"/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641" dirty="0" err="1">
                <a:latin typeface="Arial" panose="020B0604020202020204" pitchFamily="34" charset="0"/>
                <a:cs typeface="Arial" panose="020B0604020202020204" pitchFamily="34" charset="0"/>
              </a:rPr>
              <a:t>including</a:t>
            </a:r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 US RNA and 2LTR)</a:t>
            </a:r>
          </a:p>
        </p:txBody>
      </p:sp>
      <p:sp>
        <p:nvSpPr>
          <p:cNvPr id="36" name="ZoneTexte 35"/>
          <p:cNvSpPr txBox="1"/>
          <p:nvPr/>
        </p:nvSpPr>
        <p:spPr>
          <a:xfrm>
            <a:off x="4117319" y="6938365"/>
            <a:ext cx="418704" cy="344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1859545" y="6933790"/>
            <a:ext cx="418704" cy="344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2992492" y="8744210"/>
            <a:ext cx="418704" cy="344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9966848" y="6931407"/>
            <a:ext cx="301686" cy="344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7733631" y="6938365"/>
            <a:ext cx="301686" cy="344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8806912" y="8666430"/>
            <a:ext cx="418704" cy="344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4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617831" y="5543175"/>
            <a:ext cx="348172" cy="445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29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6293978" y="5543175"/>
            <a:ext cx="348172" cy="445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29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8039132" y="14975900"/>
            <a:ext cx="28793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file 5: Fig. S1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031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58</Words>
  <Application>Microsoft Office PowerPoint</Application>
  <PresentationFormat>Personnalisé</PresentationFormat>
  <Paragraphs>3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gonaute</dc:creator>
  <cp:lastModifiedBy>Argonaute</cp:lastModifiedBy>
  <cp:revision>5</cp:revision>
  <dcterms:created xsi:type="dcterms:W3CDTF">2019-11-19T16:42:24Z</dcterms:created>
  <dcterms:modified xsi:type="dcterms:W3CDTF">2020-07-30T09:38:13Z</dcterms:modified>
</cp:coreProperties>
</file>